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1D6C4-0F4E-4095-AB47-56B2C296769D}" type="datetimeFigureOut">
              <a:rPr lang="en-IN" smtClean="0"/>
              <a:t>24-06-201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34BA3-24EF-4A37-8630-4C601E83A39C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ext Box 4"/>
          <p:cNvSpPr txBox="1">
            <a:spLocks noChangeArrowheads="1"/>
          </p:cNvSpPr>
          <p:nvPr/>
        </p:nvSpPr>
        <p:spPr bwMode="auto">
          <a:xfrm>
            <a:off x="0" y="0"/>
            <a:ext cx="245515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/>
              <a:t>Supplementary Table-S1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539751" y="404812"/>
          <a:ext cx="6095999" cy="1460260"/>
        </p:xfrm>
        <a:graphic>
          <a:graphicData uri="http://schemas.openxmlformats.org/drawingml/2006/table">
            <a:tbl>
              <a:tblPr/>
              <a:tblGrid>
                <a:gridCol w="740945"/>
                <a:gridCol w="1970963"/>
                <a:gridCol w="323729"/>
                <a:gridCol w="468983"/>
                <a:gridCol w="302868"/>
                <a:gridCol w="832888"/>
                <a:gridCol w="832888"/>
                <a:gridCol w="622735"/>
              </a:tblGrid>
              <a:tr h="130380"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Cell </a:t>
                      </a: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ype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Control </a:t>
                      </a:r>
                      <a:r>
                        <a:rPr lang="en-GB" sz="700" b="1" dirty="0" err="1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test condition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Power </a:t>
                      </a: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calculation parameters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Power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 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0380"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2583" marR="6258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2583" marR="6258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n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α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m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δ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b="1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σ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2583" marR="62583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9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SW756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NT KD </a:t>
                      </a:r>
                      <a:r>
                        <a:rPr lang="en-GB" sz="700" i="1" dirty="0" err="1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GM2 KD (+ OSM)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0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5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09983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1042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954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9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SW756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NT KD </a:t>
                      </a:r>
                      <a:r>
                        <a:rPr lang="en-GB" sz="700" i="1" dirty="0" err="1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GM2 KD (- OSM)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0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5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0.001079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06668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9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SW756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GFP alone </a:t>
                      </a:r>
                      <a:r>
                        <a:rPr lang="en-GB" sz="700" i="1" dirty="0" err="1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GFP + TGM2 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0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5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-0.002223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1905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993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9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Caski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NT KD </a:t>
                      </a:r>
                      <a:r>
                        <a:rPr lang="en-GB" sz="700" i="1" dirty="0" err="1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TGM2 KD (+ OSM)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0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5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3473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1176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990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Caski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GFP alone </a:t>
                      </a:r>
                      <a:r>
                        <a:rPr lang="en-GB" sz="700" i="1" dirty="0" err="1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vs</a:t>
                      </a:r>
                      <a:r>
                        <a:rPr lang="en-GB" sz="700" dirty="0" smtClean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 </a:t>
                      </a: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GFP + TGM2 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30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5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-0.003028</a:t>
                      </a:r>
                      <a:endParaRPr lang="en-GB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0.001489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700" dirty="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  <a:cs typeface="Calibri"/>
                        </a:rPr>
                        <a:t>1</a:t>
                      </a:r>
                      <a:endParaRPr lang="en-GB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83444" marR="83444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On-screen Show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hadevan.v</dc:creator>
  <cp:lastModifiedBy>mahadevan.v</cp:lastModifiedBy>
  <cp:revision>2</cp:revision>
  <dcterms:created xsi:type="dcterms:W3CDTF">2013-06-24T07:27:38Z</dcterms:created>
  <dcterms:modified xsi:type="dcterms:W3CDTF">2013-06-24T07:27:59Z</dcterms:modified>
</cp:coreProperties>
</file>